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216" y="48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7AEF287-7366-45D0-B67C-950FABB4B48C}" type="datetimeFigureOut">
              <a:rPr lang="zh-CN" altLang="en-US" smtClean="0"/>
              <a:t>2013-9-4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5E60559-3368-4CC4-90CF-3EF32FD4922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9654992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5E60559-3368-4CC4-90CF-3EF32FD49220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0368470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3-9-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3-9-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3-9-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3-9-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3-9-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3-9-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3-9-4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3-9-4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3-9-4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3-9-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3-9-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13-9-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526" name="Group 382"/>
          <p:cNvGraphicFramePr>
            <a:graphicFrameLocks noGrp="1"/>
          </p:cNvGraphicFramePr>
          <p:nvPr/>
        </p:nvGraphicFramePr>
        <p:xfrm>
          <a:off x="1187450" y="1196975"/>
          <a:ext cx="6624638" cy="3743317"/>
        </p:xfrm>
        <a:graphic>
          <a:graphicData uri="http://schemas.openxmlformats.org/drawingml/2006/table">
            <a:tbl>
              <a:tblPr/>
              <a:tblGrid>
                <a:gridCol w="504825"/>
                <a:gridCol w="650875"/>
                <a:gridCol w="508000"/>
                <a:gridCol w="361950"/>
                <a:gridCol w="528638"/>
                <a:gridCol w="341312"/>
                <a:gridCol w="549275"/>
                <a:gridCol w="333375"/>
                <a:gridCol w="277813"/>
                <a:gridCol w="549275"/>
                <a:gridCol w="277812"/>
                <a:gridCol w="620713"/>
                <a:gridCol w="296862"/>
                <a:gridCol w="482600"/>
                <a:gridCol w="341313"/>
              </a:tblGrid>
              <a:tr h="137183"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Pair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Sample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6"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zh-CN" altLang="en-US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　</a:t>
                      </a:r>
                      <a:r>
                        <a:rPr kumimoji="0" lang="en-US" altLang="zh-CN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NaOH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zh-CN" altLang="en-US" sz="9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　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6"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zh-CN" altLang="en-US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　</a:t>
                      </a:r>
                      <a:r>
                        <a:rPr kumimoji="0" lang="en-US" altLang="zh-CN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H</a:t>
                      </a:r>
                      <a:r>
                        <a:rPr kumimoji="0" lang="en-US" altLang="zh-CN" sz="800" b="1" i="0" u="none" strike="noStrike" cap="none" normalizeH="0" baseline="-2500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2</a:t>
                      </a:r>
                      <a:r>
                        <a:rPr kumimoji="0" lang="en-US" altLang="zh-CN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SO</a:t>
                      </a:r>
                      <a:r>
                        <a:rPr kumimoji="0" lang="en-US" altLang="zh-CN" sz="800" b="1" i="0" u="none" strike="noStrike" cap="none" normalizeH="0" baseline="-2500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4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</a:tr>
              <a:tr h="122258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5%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1%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4%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zh-CN" altLang="en-US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　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0.25%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1%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4%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</a:tr>
              <a:tr h="182910"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I-1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TaLq27(H)</a:t>
                      </a:r>
                      <a:r>
                        <a:rPr kumimoji="0" lang="en-US" altLang="zh-CN" sz="800" b="1" i="0" u="none" strike="noStrike" cap="none" normalizeH="0" baseline="3000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 </a:t>
                      </a:r>
                      <a:r>
                        <a:rPr kumimoji="0" lang="en-US" altLang="zh-CN" sz="1200" b="1" i="0" u="none" strike="noStrike" cap="none" normalizeH="0" baseline="3000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&amp;</a:t>
                      </a:r>
                      <a:endParaRPr kumimoji="0" lang="en-US" altLang="zh-CN" sz="12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41.1±1.2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1.2</a:t>
                      </a:r>
                      <a:r>
                        <a:rPr kumimoji="0" lang="en-US" altLang="zh-CN" sz="1200" b="1" i="0" u="none" strike="noStrike" cap="none" normalizeH="0" baseline="3000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@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45.8±1.5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1.2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53.4±1.4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1.1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24.3±0.5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1.4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50.8±0.2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1.3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50.0±0.4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1.1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22258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TaLq98(L)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34.8±0.1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38.4±1.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46.9±1.2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17.9±0.4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38.7±0.3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43.7±1.2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</a:tr>
              <a:tr h="122258"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22258"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I-2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TaLq1(H)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43.9±0.3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1.3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50.8±1.2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1.3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55.4±0.5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1.2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23.8±0.4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1.2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49.9±0.8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1.2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49.2±1.9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1.2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22258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TaLq47(L)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32.7±1.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37.8±0.4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46.6±0.9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19.1±0.3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42.7±0.7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41.5±0.2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</a:tr>
              <a:tr h="122258"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22258"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I-3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TaLq107(H)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45.9±0.3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1.7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47.8±1.2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1.2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66.9±1.3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1.5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25.9±0.5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1.6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55.2±0.6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1.3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54.0±0.5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1.3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22258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TaLq93(L)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27.5±0.8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40.6±2.7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44.8±0.2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16.7±0.1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42.8±0.3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42.6±1.6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</a:tr>
              <a:tr h="122258"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22258"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22258"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II-1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TaLq1(H)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43.9±0.3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1.2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50.8±1.2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1.3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55.4±0.5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1.1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23.8±0.4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1.2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49.9±0.8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1.1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49.2±1.9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1.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22258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TaLq71(L)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35.8±0.8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38.2±3.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51.5±0.6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19.4±0.4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46.1±0.4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47.8±0.5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</a:tr>
              <a:tr h="122258"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22258"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II-2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TaLq107(H)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45.9±0.3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1.2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47.8±1.2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1.1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66.9±1.3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1.3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25.9±0.5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1.1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55.2±0.6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1.1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54.0±0.5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1.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22258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TaLq58(L)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39.0±0.3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42.5±0.7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53.3±0.7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24.1±0.3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50.6±1.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52.4±0.1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</a:tr>
              <a:tr h="122258"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22258"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II-3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TaLq46(H)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40.1±0.2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1.2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45.6±0.9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1.2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51.4±0.8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1.1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22.1±0.2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1.2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47.2±0.2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1.1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45.1±0.6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1.1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22258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TaLq47(L)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32.7±1.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37.8±0.4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46.6±0.9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19.1±0.3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42.7±0.7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41.5±0.2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</a:tr>
              <a:tr h="122258"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22258"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22258"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III-1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1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Osfc27</a:t>
                      </a: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(H)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45.8±0.9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1.2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72.3±2.2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1.9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89.2±2.3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1.7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75.4±1.4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2.9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82.6±1.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1.8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83.1±1.3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1.7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22258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TaLq71(L)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35.8±0.8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38.2±3.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51.5±0.6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19.4±0.4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46.1±0.4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47.8±0.5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</a:tr>
              <a:tr h="122258"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22258"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III-2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1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Osfc2</a:t>
                      </a: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(H)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43.9±1.4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1.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76.9±1.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1.6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87.1±4.6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1.5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73.3±0.7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2.1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84.4±2.6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1.7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85.1±4.2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1.7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22258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TaLq85(L)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43.8±0.5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48.0±1.2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57.8±0.2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23.9±0.8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50.4±0.5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49.8±1.2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</a:tr>
              <a:tr h="122258"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22258"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III-3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1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Osfc32</a:t>
                      </a: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(H)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47.7±0.3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1.1</a:t>
                      </a:r>
                      <a:r>
                        <a:rPr kumimoji="0" lang="zh-CN" alt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　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74.2±0.1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1.6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96.1±1.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1.8</a:t>
                      </a:r>
                      <a:r>
                        <a:rPr kumimoji="0" lang="zh-CN" alt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　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65.8±1.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1.7</a:t>
                      </a:r>
                      <a:r>
                        <a:rPr kumimoji="0" lang="zh-CN" alt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　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86.4±1.4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1.7</a:t>
                      </a:r>
                      <a:r>
                        <a:rPr kumimoji="0" lang="zh-CN" alt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　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84.0±1.8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1.7</a:t>
                      </a:r>
                      <a:r>
                        <a:rPr kumimoji="0" lang="zh-CN" alt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　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22258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TaLq27(L)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41.1±1.2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45.8±1.5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53.4±1.4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zh-CN" alt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　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24.3±0.5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50.8±0.2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</a:rPr>
                        <a:t>50.0±0.4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</a:tr>
            </a:tbl>
          </a:graphicData>
        </a:graphic>
      </p:graphicFrame>
      <p:sp>
        <p:nvSpPr>
          <p:cNvPr id="6521" name="Rectangle 993"/>
          <p:cNvSpPr>
            <a:spLocks noGrp="1" noChangeArrowheads="1"/>
          </p:cNvSpPr>
          <p:nvPr>
            <p:ph type="title"/>
          </p:nvPr>
        </p:nvSpPr>
        <p:spPr>
          <a:xfrm>
            <a:off x="1043608" y="979265"/>
            <a:ext cx="5759450" cy="217487"/>
          </a:xfrm>
        </p:spPr>
        <p:txBody>
          <a:bodyPr>
            <a:noAutofit/>
          </a:bodyPr>
          <a:lstStyle/>
          <a:p>
            <a:r>
              <a:rPr lang="zh-CN" altLang="zh-CN" sz="1000" b="1" dirty="0" smtClean="0">
                <a:latin typeface="Arial" pitchFamily="34" charset="0"/>
                <a:cs typeface="Arial" pitchFamily="34" charset="0"/>
              </a:rPr>
              <a:t>Table S</a:t>
            </a:r>
            <a:r>
              <a:rPr lang="en-US" altLang="zh-CN" sz="1000" b="1" dirty="0" smtClean="0">
                <a:latin typeface="Arial" pitchFamily="34" charset="0"/>
                <a:cs typeface="Arial" pitchFamily="34" charset="0"/>
              </a:rPr>
              <a:t>2</a:t>
            </a:r>
            <a:r>
              <a:rPr lang="zh-CN" altLang="zh-CN" sz="1000" dirty="0" smtClean="0">
                <a:latin typeface="Arial" pitchFamily="34" charset="0"/>
                <a:cs typeface="Arial" pitchFamily="34" charset="0"/>
              </a:rPr>
              <a:t>. Total sugar yield (% </a:t>
            </a:r>
            <a:r>
              <a:rPr lang="en-US" altLang="zh-CN" sz="1000" dirty="0" smtClean="0">
                <a:latin typeface="Arial" pitchFamily="34" charset="0"/>
                <a:cs typeface="Arial" pitchFamily="34" charset="0"/>
              </a:rPr>
              <a:t>cell wall</a:t>
            </a:r>
            <a:r>
              <a:rPr lang="zh-CN" altLang="zh-CN" sz="1000" dirty="0" smtClean="0">
                <a:latin typeface="Arial" pitchFamily="34" charset="0"/>
                <a:cs typeface="Arial" pitchFamily="34" charset="0"/>
              </a:rPr>
              <a:t>) released from both enzymatic hydrolysis and pretreatment</a:t>
            </a:r>
          </a:p>
        </p:txBody>
      </p:sp>
      <p:sp>
        <p:nvSpPr>
          <p:cNvPr id="6522" name="Rectangle 994"/>
          <p:cNvSpPr>
            <a:spLocks noChangeArrowheads="1"/>
          </p:cNvSpPr>
          <p:nvPr/>
        </p:nvSpPr>
        <p:spPr bwMode="auto">
          <a:xfrm>
            <a:off x="1116013" y="4941888"/>
            <a:ext cx="6697662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en-GB" altLang="en-US" sz="1200" b="1" baseline="30000" dirty="0">
                <a:latin typeface="Arial" pitchFamily="34" charset="0"/>
                <a:cs typeface="Arial" pitchFamily="34" charset="0"/>
                <a:sym typeface="宋体" pitchFamily="2" charset="-122"/>
              </a:rPr>
              <a:t>&amp;</a:t>
            </a:r>
            <a:r>
              <a:rPr lang="en-US" altLang="zh-CN" sz="1000" baseline="0" dirty="0">
                <a:latin typeface="Arial" pitchFamily="34" charset="0"/>
                <a:cs typeface="Arial" pitchFamily="34" charset="0"/>
                <a:sym typeface="宋体" pitchFamily="2" charset="-122"/>
              </a:rPr>
              <a:t>,</a:t>
            </a:r>
            <a:r>
              <a:rPr lang="zh-CN" altLang="en-US" sz="1000" baseline="0" dirty="0">
                <a:latin typeface="Arial" pitchFamily="34" charset="0"/>
                <a:cs typeface="Arial" pitchFamily="34" charset="0"/>
                <a:sym typeface="宋体" pitchFamily="2" charset="-122"/>
              </a:rPr>
              <a:t> </a:t>
            </a:r>
            <a:r>
              <a:rPr lang="zh-CN" altLang="en-US" sz="1000" baseline="0" dirty="0" smtClean="0">
                <a:latin typeface="Arial" pitchFamily="34" charset="0"/>
                <a:cs typeface="Arial" pitchFamily="34" charset="0"/>
                <a:sym typeface="宋体" pitchFamily="2" charset="-122"/>
              </a:rPr>
              <a:t> (</a:t>
            </a:r>
            <a:r>
              <a:rPr lang="zh-CN" altLang="en-US" sz="1000" baseline="0" dirty="0">
                <a:latin typeface="Arial" pitchFamily="34" charset="0"/>
                <a:cs typeface="Arial" pitchFamily="34" charset="0"/>
                <a:sym typeface="宋体" pitchFamily="2" charset="-122"/>
              </a:rPr>
              <a:t>H) or (L) Indicated the sample in the pair with high (H) or low (L)  biomass digestibility</a:t>
            </a:r>
            <a:r>
              <a:rPr lang="en-US" altLang="zh-CN" sz="1000" baseline="0" dirty="0">
                <a:latin typeface="Arial" pitchFamily="34" charset="0"/>
                <a:cs typeface="Arial" pitchFamily="34" charset="0"/>
                <a:sym typeface="宋体" pitchFamily="2" charset="-122"/>
              </a:rPr>
              <a:t>;</a:t>
            </a:r>
            <a:endParaRPr lang="zh-CN" altLang="en-US" sz="1000" baseline="0" dirty="0">
              <a:latin typeface="Arial" pitchFamily="34" charset="0"/>
              <a:cs typeface="Arial" pitchFamily="34" charset="0"/>
              <a:sym typeface="宋体" pitchFamily="2" charset="-122"/>
            </a:endParaRPr>
          </a:p>
          <a:p>
            <a:r>
              <a:rPr lang="en-US" altLang="zh-CN" sz="1200" b="1" baseline="30000" dirty="0">
                <a:latin typeface="Arial" pitchFamily="34" charset="0"/>
                <a:cs typeface="Arial" pitchFamily="34" charset="0"/>
              </a:rPr>
              <a:t>@</a:t>
            </a:r>
            <a:r>
              <a:rPr lang="en-US" altLang="zh-CN" sz="1000" baseline="0" dirty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,</a:t>
            </a:r>
            <a:r>
              <a:rPr lang="zh-CN" altLang="en-US" sz="1000" baseline="0" dirty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 </a:t>
            </a:r>
            <a:r>
              <a:rPr lang="en-GB" altLang="en-US" sz="1000" baseline="0" dirty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Ratio of two sample values at pair.</a:t>
            </a:r>
          </a:p>
        </p:txBody>
      </p:sp>
    </p:spTree>
    <p:extLst>
      <p:ext uri="{BB962C8B-B14F-4D97-AF65-F5344CB8AC3E}">
        <p14:creationId xmlns:p14="http://schemas.microsoft.com/office/powerpoint/2010/main" val="403108465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79</Words>
  <Application>Microsoft Office PowerPoint</Application>
  <PresentationFormat>全屏显示(4:3)</PresentationFormat>
  <Paragraphs>206</Paragraphs>
  <Slides>1</Slides>
  <Notes>1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Table S2. Total sugar yield (% cell wall) released from both enzymatic hydrolysis and pretreatme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Table S2. Total sugar yield (% cell wall) released from both enzymatic hydrolysis and pretreatment</dc:title>
  <cp:lastModifiedBy>微软用户</cp:lastModifiedBy>
  <cp:revision>3</cp:revision>
  <dcterms:modified xsi:type="dcterms:W3CDTF">2013-09-04T07:13:39Z</dcterms:modified>
</cp:coreProperties>
</file>